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91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默认节" id="{B0AF0151-9361-4123-8B5E-D38324843CE7}">
          <p14:sldIdLst/>
        </p14:section>
        <p14:section name="无标题节" id="{031C27FF-B83F-4552-8E20-7CF25D858727}">
          <p14:sldIdLst>
            <p14:sldId id="291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engzhishu2009@163.com" initials="f" lastIdx="10" clrIdx="0">
    <p:extLst>
      <p:ext uri="{19B8F6BF-5375-455C-9EA6-DF929625EA0E}">
        <p15:presenceInfo xmlns:p15="http://schemas.microsoft.com/office/powerpoint/2012/main" userId="696e086e05cbe200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284F9E"/>
    <a:srgbClr val="595959"/>
    <a:srgbClr val="6E4D83"/>
    <a:srgbClr val="F2A2DF"/>
    <a:srgbClr val="E6E6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891" autoAdjust="0"/>
    <p:restoredTop sz="93826" autoAdjust="0"/>
  </p:normalViewPr>
  <p:slideViewPr>
    <p:cSldViewPr snapToGrid="0" showGuides="1">
      <p:cViewPr varScale="1">
        <p:scale>
          <a:sx n="44" d="100"/>
          <a:sy n="44" d="100"/>
        </p:scale>
        <p:origin x="2116" y="5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23454;&#39564;&#25968;&#25454;\&#23450;&#37327;&#32467;&#26524;\2020\2020&#31319;&#22411;&#30456;&#20851;&#22522;&#22240;&#23450;&#37327;\20200908-5%20osh43%20d11%20sp1%20osh6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23454;&#39564;&#25968;&#25454;\&#23450;&#37327;&#32467;&#26524;\2019\&#31319;&#22411;&#30456;&#20851;&#22522;&#22240;&#23450;&#37327;\20191018-2%20OSH15%20OSH71%20OSH15.xl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23454;&#39564;&#25968;&#25454;\&#23450;&#37327;&#32467;&#26524;\2019\&#31319;&#22411;&#30456;&#20851;&#22522;&#22240;&#23450;&#37327;\20191018-2%20OSH15%20OSH71%20OSH15.xl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23454;&#39564;&#25968;&#25454;\&#23450;&#37327;&#32467;&#26524;\2020\2020&#31319;&#22411;&#30456;&#20851;&#22522;&#22240;&#23450;&#37327;\20200908-5%20osh43%20d11%20sp1%20osh6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23454;&#39564;&#25968;&#25454;\&#23450;&#37327;&#32467;&#26524;\&#23450;&#37327;%202017sd1%2020ox1%20OSH1%206%2015%2043%2071\20171127OSH1%20&#20108;&#27425;.xls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B87-42BD-AB36-E1F16FBA9C10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1">
                  <a:lumMod val="20000"/>
                  <a:lumOff val="8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AB87-42BD-AB36-E1F16FBA9C10}"/>
              </c:ext>
            </c:extLst>
          </c:dPt>
          <c:errBars>
            <c:errBarType val="both"/>
            <c:errValType val="cust"/>
            <c:noEndCap val="0"/>
            <c:plus>
              <c:numRef>
                <c:f>Sheet2!$L$10:$L$11</c:f>
                <c:numCache>
                  <c:formatCode>General</c:formatCode>
                  <c:ptCount val="2"/>
                  <c:pt idx="0">
                    <c:v>6.8836477533202906E-2</c:v>
                  </c:pt>
                  <c:pt idx="1">
                    <c:v>0.13195839857847855</c:v>
                  </c:pt>
                </c:numCache>
              </c:numRef>
            </c:plus>
            <c:minus>
              <c:numRef>
                <c:f>Sheet2!$L$10:$L$11</c:f>
                <c:numCache>
                  <c:formatCode>General</c:formatCode>
                  <c:ptCount val="2"/>
                  <c:pt idx="0">
                    <c:v>6.8836477533202906E-2</c:v>
                  </c:pt>
                  <c:pt idx="1">
                    <c:v>0.13195839857847855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2!$O$4:$O$5</c:f>
              <c:strCache>
                <c:ptCount val="2"/>
                <c:pt idx="0">
                  <c:v>Nip</c:v>
                </c:pt>
                <c:pt idx="1">
                  <c:v>CSSL-9</c:v>
                </c:pt>
              </c:strCache>
            </c:strRef>
          </c:cat>
          <c:val>
            <c:numRef>
              <c:f>Sheet2!$P$4:$P$5</c:f>
              <c:numCache>
                <c:formatCode>General</c:formatCode>
                <c:ptCount val="2"/>
                <c:pt idx="0">
                  <c:v>0.99311635224667971</c:v>
                </c:pt>
                <c:pt idx="1">
                  <c:v>0.39131211962553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AB87-42BD-AB36-E1F16FBA9C1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646893648"/>
        <c:axId val="646890368"/>
      </c:barChart>
      <c:catAx>
        <c:axId val="6468936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646890368"/>
        <c:crosses val="autoZero"/>
        <c:auto val="1"/>
        <c:lblAlgn val="ctr"/>
        <c:lblOffset val="100"/>
        <c:noMultiLvlLbl val="0"/>
      </c:catAx>
      <c:valAx>
        <c:axId val="64689036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6468936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B56-40CF-A8EE-22B761B04D49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1">
                  <a:lumMod val="20000"/>
                  <a:lumOff val="8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B56-40CF-A8EE-22B761B04D49}"/>
              </c:ext>
            </c:extLst>
          </c:dPt>
          <c:errBars>
            <c:errBarType val="both"/>
            <c:errValType val="cust"/>
            <c:noEndCap val="0"/>
            <c:plus>
              <c:numRef>
                <c:f>Sheet2!$N$29:$N$30</c:f>
                <c:numCache>
                  <c:formatCode>General</c:formatCode>
                  <c:ptCount val="2"/>
                  <c:pt idx="0">
                    <c:v>3.3483504231596739E-2</c:v>
                  </c:pt>
                  <c:pt idx="1">
                    <c:v>1.435001445097008E-2</c:v>
                  </c:pt>
                </c:numCache>
              </c:numRef>
            </c:plus>
            <c:minus>
              <c:numRef>
                <c:f>Sheet2!$N$29:$N$30</c:f>
                <c:numCache>
                  <c:formatCode>General</c:formatCode>
                  <c:ptCount val="2"/>
                  <c:pt idx="0">
                    <c:v>3.3483504231596739E-2</c:v>
                  </c:pt>
                  <c:pt idx="1">
                    <c:v>1.435001445097008E-2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2!$K$37:$K$38</c:f>
              <c:strCache>
                <c:ptCount val="2"/>
                <c:pt idx="0">
                  <c:v>Nip</c:v>
                </c:pt>
                <c:pt idx="1">
                  <c:v>CSSL-9</c:v>
                </c:pt>
              </c:strCache>
            </c:strRef>
          </c:cat>
          <c:val>
            <c:numRef>
              <c:f>Sheet2!$L$37:$L$38</c:f>
              <c:numCache>
                <c:formatCode>General</c:formatCode>
                <c:ptCount val="2"/>
                <c:pt idx="0">
                  <c:v>0.96651649576840326</c:v>
                </c:pt>
                <c:pt idx="1">
                  <c:v>0.404512780378815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2B56-40CF-A8EE-22B761B04D4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470355304"/>
        <c:axId val="470356616"/>
      </c:barChart>
      <c:catAx>
        <c:axId val="4703553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470356616"/>
        <c:crosses val="autoZero"/>
        <c:auto val="1"/>
        <c:lblAlgn val="ctr"/>
        <c:lblOffset val="100"/>
        <c:noMultiLvlLbl val="0"/>
      </c:catAx>
      <c:valAx>
        <c:axId val="47035661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4703553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solidFill>
        <a:schemeClr val="bg1"/>
      </a:solidFill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>
                <a:lumMod val="60000"/>
                <a:lumOff val="40000"/>
              </a:schemeClr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accent1">
                  <a:lumMod val="20000"/>
                  <a:lumOff val="8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B5B2-4091-9D84-19F0714DF261}"/>
              </c:ext>
            </c:extLst>
          </c:dPt>
          <c:errBars>
            <c:errBarType val="both"/>
            <c:errValType val="cust"/>
            <c:noEndCap val="0"/>
            <c:plus>
              <c:numRef>
                <c:f>Sheet2!$L$11:$L$12</c:f>
                <c:numCache>
                  <c:formatCode>General</c:formatCode>
                  <c:ptCount val="2"/>
                  <c:pt idx="0">
                    <c:v>0.10709744219752282</c:v>
                  </c:pt>
                  <c:pt idx="1">
                    <c:v>4.1897135307939787E-2</c:v>
                  </c:pt>
                </c:numCache>
              </c:numRef>
            </c:plus>
            <c:minus>
              <c:numRef>
                <c:f>Sheet2!$L$11:$L$12</c:f>
                <c:numCache>
                  <c:formatCode>General</c:formatCode>
                  <c:ptCount val="2"/>
                  <c:pt idx="0">
                    <c:v>0.10709744219752282</c:v>
                  </c:pt>
                  <c:pt idx="1">
                    <c:v>4.1897135307939787E-2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2!$O$11:$O$12</c:f>
              <c:strCache>
                <c:ptCount val="2"/>
                <c:pt idx="0">
                  <c:v>Nip</c:v>
                </c:pt>
                <c:pt idx="1">
                  <c:v>CSSL-9</c:v>
                </c:pt>
              </c:strCache>
            </c:strRef>
          </c:cat>
          <c:val>
            <c:numRef>
              <c:f>Sheet2!$P$11:$P$12</c:f>
              <c:numCache>
                <c:formatCode>General</c:formatCode>
                <c:ptCount val="2"/>
                <c:pt idx="0">
                  <c:v>1.1070974421975228</c:v>
                </c:pt>
                <c:pt idx="1">
                  <c:v>0.344731730202221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5B2-4091-9D84-19F0714DF26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470338248"/>
        <c:axId val="470344152"/>
      </c:barChart>
      <c:catAx>
        <c:axId val="4703382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470344152"/>
        <c:crosses val="autoZero"/>
        <c:auto val="1"/>
        <c:lblAlgn val="ctr"/>
        <c:lblOffset val="100"/>
        <c:noMultiLvlLbl val="0"/>
      </c:catAx>
      <c:valAx>
        <c:axId val="4703441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4703382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bg1"/>
      </a:solidFill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4BC-4834-9DF5-C561E3215BFB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1">
                  <a:lumMod val="20000"/>
                  <a:lumOff val="8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4BC-4834-9DF5-C561E3215BFB}"/>
              </c:ext>
            </c:extLst>
          </c:dPt>
          <c:errBars>
            <c:errBarType val="both"/>
            <c:errValType val="cust"/>
            <c:noEndCap val="0"/>
            <c:plus>
              <c:numRef>
                <c:f>Sheet2!$L$48:$L$49</c:f>
                <c:numCache>
                  <c:formatCode>General</c:formatCode>
                  <c:ptCount val="2"/>
                  <c:pt idx="0">
                    <c:v>0.33126727325646171</c:v>
                  </c:pt>
                  <c:pt idx="1">
                    <c:v>2.4307980798319629E-2</c:v>
                  </c:pt>
                </c:numCache>
              </c:numRef>
            </c:plus>
            <c:minus>
              <c:numRef>
                <c:f>Sheet2!$L$48:$L$49</c:f>
                <c:numCache>
                  <c:formatCode>General</c:formatCode>
                  <c:ptCount val="2"/>
                  <c:pt idx="0">
                    <c:v>0.33126727325646171</c:v>
                  </c:pt>
                  <c:pt idx="1">
                    <c:v>2.4307980798319629E-2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2!$N$43:$N$44</c:f>
              <c:strCache>
                <c:ptCount val="2"/>
                <c:pt idx="0">
                  <c:v>Nip</c:v>
                </c:pt>
                <c:pt idx="1">
                  <c:v>CSSL-9</c:v>
                </c:pt>
              </c:strCache>
            </c:strRef>
          </c:cat>
          <c:val>
            <c:numRef>
              <c:f>Sheet2!$O$43:$O$44</c:f>
              <c:numCache>
                <c:formatCode>General</c:formatCode>
                <c:ptCount val="2"/>
                <c:pt idx="0">
                  <c:v>1.4359158908775773</c:v>
                </c:pt>
                <c:pt idx="1">
                  <c:v>0.818258215649066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14BC-4834-9DF5-C561E3215BF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646887744"/>
        <c:axId val="646888072"/>
      </c:barChart>
      <c:catAx>
        <c:axId val="6468877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646888072"/>
        <c:crosses val="autoZero"/>
        <c:auto val="1"/>
        <c:lblAlgn val="ctr"/>
        <c:lblOffset val="100"/>
        <c:noMultiLvlLbl val="0"/>
      </c:catAx>
      <c:valAx>
        <c:axId val="646888072"/>
        <c:scaling>
          <c:orientation val="minMax"/>
          <c:max val="1.8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6468877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bg1"/>
      </a:solidFill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17169215916975894"/>
          <c:y val="5.8138949294207209E-2"/>
          <c:w val="0.78999366458503029"/>
          <c:h val="0.850247443207530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4!$I$23</c:f>
              <c:strCache>
                <c:ptCount val="1"/>
              </c:strCache>
            </c:strRef>
          </c:tx>
          <c:spPr>
            <a:solidFill>
              <a:schemeClr val="accent1">
                <a:lumMod val="40000"/>
                <a:lumOff val="60000"/>
              </a:schemeClr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A61E-4CDD-8099-9FEA4CAF6A7C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1">
                  <a:lumMod val="20000"/>
                  <a:lumOff val="8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A61E-4CDD-8099-9FEA4CAF6A7C}"/>
              </c:ext>
            </c:extLst>
          </c:dPt>
          <c:errBars>
            <c:errBarType val="both"/>
            <c:errValType val="cust"/>
            <c:noEndCap val="0"/>
            <c:plus>
              <c:numRef>
                <c:f>Sheet4!$E$22:$F$22</c:f>
                <c:numCache>
                  <c:formatCode>General</c:formatCode>
                  <c:ptCount val="2"/>
                  <c:pt idx="0">
                    <c:v>0.10556214609217947</c:v>
                  </c:pt>
                  <c:pt idx="1">
                    <c:v>7.7265139085313198E-2</c:v>
                  </c:pt>
                </c:numCache>
              </c:numRef>
            </c:plus>
            <c:minus>
              <c:numRef>
                <c:f>Sheet4!$E$22:$F$22</c:f>
                <c:numCache>
                  <c:formatCode>General</c:formatCode>
                  <c:ptCount val="2"/>
                  <c:pt idx="0">
                    <c:v>0.10556214609217947</c:v>
                  </c:pt>
                  <c:pt idx="1">
                    <c:v>7.7265139085313198E-2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4!$H$24:$H$25</c:f>
              <c:strCache>
                <c:ptCount val="2"/>
                <c:pt idx="0">
                  <c:v>Nip</c:v>
                </c:pt>
                <c:pt idx="1">
                  <c:v>CSSL-9</c:v>
                </c:pt>
              </c:strCache>
            </c:strRef>
          </c:cat>
          <c:val>
            <c:numRef>
              <c:f>Sheet4!$I$24:$I$25</c:f>
              <c:numCache>
                <c:formatCode>General</c:formatCode>
                <c:ptCount val="2"/>
                <c:pt idx="0">
                  <c:v>1.0503551860600762</c:v>
                </c:pt>
                <c:pt idx="1">
                  <c:v>0.844843888388593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61E-4CDD-8099-9FEA4CAF6A7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466291592"/>
        <c:axId val="466283392"/>
      </c:barChart>
      <c:catAx>
        <c:axId val="4662915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466283392"/>
        <c:crosses val="autoZero"/>
        <c:auto val="1"/>
        <c:lblAlgn val="ctr"/>
        <c:lblOffset val="100"/>
        <c:noMultiLvlLbl val="0"/>
      </c:catAx>
      <c:valAx>
        <c:axId val="466283392"/>
        <c:scaling>
          <c:orientation val="minMax"/>
          <c:max val="1.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4662915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solidFill>
        <a:schemeClr val="bg1"/>
      </a:solidFill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66FED27-533D-4C2F-96A3-38C026D66261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01FFB7C-A235-4241-9546-2785CD185C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33134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12564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49213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36718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05543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88894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76794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96245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09151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6088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86010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86330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71968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09B3C32B-831E-4AD0-85E9-C5ABBBE360B9}"/>
              </a:ext>
            </a:extLst>
          </p:cNvPr>
          <p:cNvGrpSpPr/>
          <p:nvPr/>
        </p:nvGrpSpPr>
        <p:grpSpPr>
          <a:xfrm>
            <a:off x="1278486" y="2897514"/>
            <a:ext cx="4301028" cy="4110971"/>
            <a:chOff x="988997" y="3551125"/>
            <a:chExt cx="4301028" cy="4110971"/>
          </a:xfrm>
        </p:grpSpPr>
        <p:graphicFrame>
          <p:nvGraphicFramePr>
            <p:cNvPr id="31" name="图表 30">
              <a:extLst>
                <a:ext uri="{FF2B5EF4-FFF2-40B4-BE49-F238E27FC236}">
                  <a16:creationId xmlns:a16="http://schemas.microsoft.com/office/drawing/2014/main" id="{B9FB2E12-67EA-4F93-A8CB-9BC8539114DA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22039684"/>
                </p:ext>
              </p:extLst>
            </p:nvPr>
          </p:nvGraphicFramePr>
          <p:xfrm>
            <a:off x="1136385" y="3571619"/>
            <a:ext cx="1491440" cy="198226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36" name="图表 35">
              <a:extLst>
                <a:ext uri="{FF2B5EF4-FFF2-40B4-BE49-F238E27FC236}">
                  <a16:creationId xmlns:a16="http://schemas.microsoft.com/office/drawing/2014/main" id="{CA7D154B-50EB-4903-969B-6A03111D8F6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821663329"/>
                </p:ext>
              </p:extLst>
            </p:nvPr>
          </p:nvGraphicFramePr>
          <p:xfrm>
            <a:off x="3424074" y="5678264"/>
            <a:ext cx="1514013" cy="197161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34" name="图表 33">
              <a:extLst>
                <a:ext uri="{FF2B5EF4-FFF2-40B4-BE49-F238E27FC236}">
                  <a16:creationId xmlns:a16="http://schemas.microsoft.com/office/drawing/2014/main" id="{27B3122C-2491-47D4-8389-62BCE49D4DBC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28699547"/>
                </p:ext>
              </p:extLst>
            </p:nvPr>
          </p:nvGraphicFramePr>
          <p:xfrm>
            <a:off x="1955782" y="5671091"/>
            <a:ext cx="1514013" cy="199100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32" name="图表 31">
              <a:extLst>
                <a:ext uri="{FF2B5EF4-FFF2-40B4-BE49-F238E27FC236}">
                  <a16:creationId xmlns:a16="http://schemas.microsoft.com/office/drawing/2014/main" id="{584991D4-F073-45C6-AC84-63FC5651863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253360007"/>
                </p:ext>
              </p:extLst>
            </p:nvPr>
          </p:nvGraphicFramePr>
          <p:xfrm>
            <a:off x="2511440" y="3559751"/>
            <a:ext cx="1469465" cy="199496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35" name="图表 34">
              <a:extLst>
                <a:ext uri="{FF2B5EF4-FFF2-40B4-BE49-F238E27FC236}">
                  <a16:creationId xmlns:a16="http://schemas.microsoft.com/office/drawing/2014/main" id="{A01784DE-F8DA-4392-B307-667BEBFC0CD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990643192"/>
                </p:ext>
              </p:extLst>
            </p:nvPr>
          </p:nvGraphicFramePr>
          <p:xfrm>
            <a:off x="3959518" y="3571752"/>
            <a:ext cx="1330507" cy="191800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AB1C6995-4992-4D50-946B-CDCF50E293F8}"/>
                </a:ext>
              </a:extLst>
            </p:cNvPr>
            <p:cNvSpPr txBox="1"/>
            <p:nvPr/>
          </p:nvSpPr>
          <p:spPr>
            <a:xfrm>
              <a:off x="3146138" y="3557334"/>
              <a:ext cx="56768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9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i="1" dirty="0"/>
                <a:t>OSH6</a:t>
              </a:r>
              <a:endParaRPr lang="zh-CN" altLang="en-US" i="1" dirty="0"/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A0570B9B-297E-4ACA-B434-4BAA496FBFF2}"/>
                </a:ext>
              </a:extLst>
            </p:cNvPr>
            <p:cNvSpPr txBox="1"/>
            <p:nvPr/>
          </p:nvSpPr>
          <p:spPr>
            <a:xfrm>
              <a:off x="4505796" y="3557594"/>
              <a:ext cx="51518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9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i="1" dirty="0"/>
                <a:t>OSH1</a:t>
              </a:r>
              <a:endParaRPr lang="zh-CN" altLang="en-US" i="1" dirty="0"/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FC3FE80F-053C-40E8-B50B-4FC32851D26F}"/>
                </a:ext>
              </a:extLst>
            </p:cNvPr>
            <p:cNvSpPr txBox="1"/>
            <p:nvPr/>
          </p:nvSpPr>
          <p:spPr>
            <a:xfrm>
              <a:off x="2630713" y="5669895"/>
              <a:ext cx="542262" cy="230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9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i="1" dirty="0"/>
                <a:t>OSH15</a:t>
              </a:r>
              <a:endParaRPr lang="zh-CN" altLang="en-US" i="1" dirty="0"/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A624C181-A031-4B9F-9758-5A218E8DA7F9}"/>
                </a:ext>
              </a:extLst>
            </p:cNvPr>
            <p:cNvSpPr txBox="1"/>
            <p:nvPr/>
          </p:nvSpPr>
          <p:spPr>
            <a:xfrm>
              <a:off x="2917917" y="6691993"/>
              <a:ext cx="38317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900" b="1" dirty="0"/>
                <a:t>**</a:t>
              </a: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69BAB02C-A348-46D7-AD8A-800B68BEA056}"/>
                </a:ext>
              </a:extLst>
            </p:cNvPr>
            <p:cNvSpPr txBox="1"/>
            <p:nvPr/>
          </p:nvSpPr>
          <p:spPr>
            <a:xfrm>
              <a:off x="4093735" y="5667046"/>
              <a:ext cx="56901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9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i="1" dirty="0"/>
                <a:t>OSH71</a:t>
              </a:r>
              <a:endParaRPr lang="zh-CN" altLang="en-US" i="1" dirty="0"/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0369CEAB-37BF-4C57-9D52-8AE5BD12E8F8}"/>
                </a:ext>
              </a:extLst>
            </p:cNvPr>
            <p:cNvSpPr txBox="1"/>
            <p:nvPr/>
          </p:nvSpPr>
          <p:spPr>
            <a:xfrm>
              <a:off x="4383006" y="6622519"/>
              <a:ext cx="33448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900" b="1" dirty="0"/>
                <a:t>**</a:t>
              </a: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FF0F9B2E-E00D-44B7-9143-FBA586421F12}"/>
                </a:ext>
              </a:extLst>
            </p:cNvPr>
            <p:cNvSpPr txBox="1"/>
            <p:nvPr/>
          </p:nvSpPr>
          <p:spPr>
            <a:xfrm>
              <a:off x="1749372" y="3551125"/>
              <a:ext cx="567689" cy="2370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9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i="1" dirty="0"/>
                <a:t>OSH43</a:t>
              </a:r>
              <a:endParaRPr lang="zh-CN" altLang="en-US" i="1" dirty="0"/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8DBFE5D4-C9C6-4FDC-98BA-7EB99609DBD9}"/>
                </a:ext>
              </a:extLst>
            </p:cNvPr>
            <p:cNvSpPr txBox="1"/>
            <p:nvPr/>
          </p:nvSpPr>
          <p:spPr>
            <a:xfrm>
              <a:off x="2118776" y="4399266"/>
              <a:ext cx="293169" cy="2698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900" b="1" dirty="0"/>
                <a:t>*</a:t>
              </a: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28370898-4FE0-49B2-9947-C1B5B8522E24}"/>
                </a:ext>
              </a:extLst>
            </p:cNvPr>
            <p:cNvSpPr txBox="1"/>
            <p:nvPr/>
          </p:nvSpPr>
          <p:spPr>
            <a:xfrm rot="10800000">
              <a:off x="988997" y="3925041"/>
              <a:ext cx="323165" cy="105708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expression</a:t>
              </a:r>
              <a:endParaRPr lang="zh-CN" altLang="en-US" sz="900" i="1" dirty="0"/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137B996B-2C67-4E5D-BA16-42C3DF75D98C}"/>
                </a:ext>
              </a:extLst>
            </p:cNvPr>
            <p:cNvSpPr txBox="1"/>
            <p:nvPr/>
          </p:nvSpPr>
          <p:spPr>
            <a:xfrm rot="10800000">
              <a:off x="1770533" y="6022638"/>
              <a:ext cx="323165" cy="105708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expression</a:t>
              </a:r>
              <a:endParaRPr lang="zh-CN" altLang="en-US" sz="900" i="1" dirty="0"/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1382B667-6F90-40FC-8097-EE79E096CB70}"/>
                </a:ext>
              </a:extLst>
            </p:cNvPr>
            <p:cNvSpPr txBox="1"/>
            <p:nvPr/>
          </p:nvSpPr>
          <p:spPr>
            <a:xfrm>
              <a:off x="3470017" y="4319086"/>
              <a:ext cx="293169" cy="2698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900" b="1" dirty="0"/>
                <a:t>*</a:t>
              </a: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B3E85E13-82A5-48C6-9475-BCC69A8BC98F}"/>
                </a:ext>
              </a:extLst>
            </p:cNvPr>
            <p:cNvSpPr txBox="1"/>
            <p:nvPr/>
          </p:nvSpPr>
          <p:spPr>
            <a:xfrm>
              <a:off x="4892369" y="3876803"/>
              <a:ext cx="293169" cy="2698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900" b="1" dirty="0"/>
                <a:t>*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2882197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764</TotalTime>
  <Words>14</Words>
  <Application>Microsoft Office PowerPoint</Application>
  <PresentationFormat>A4 纸张(210x297 毫米)</PresentationFormat>
  <Paragraphs>1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丽春 曹</dc:creator>
  <cp:lastModifiedBy>fengzhishu2009@163.com</cp:lastModifiedBy>
  <cp:revision>648</cp:revision>
  <dcterms:created xsi:type="dcterms:W3CDTF">2019-11-29T08:26:13Z</dcterms:created>
  <dcterms:modified xsi:type="dcterms:W3CDTF">2021-07-01T12:32:41Z</dcterms:modified>
</cp:coreProperties>
</file>